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0" d="100"/>
          <a:sy n="80" d="100"/>
        </p:scale>
        <p:origin x="48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ewas\ewas-cpgs-mnase-chi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ewas\ewas-cpgs-mnase-chi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 err="1"/>
              <a:t>MNase</a:t>
            </a:r>
            <a:r>
              <a:rPr lang="en-US" b="1" dirty="0"/>
              <a:t> - 64 </a:t>
            </a:r>
            <a:r>
              <a:rPr lang="en-US" b="1" dirty="0" err="1"/>
              <a:t>CpG</a:t>
            </a:r>
            <a:r>
              <a:rPr lang="en-US" b="1" dirty="0"/>
              <a:t> sites</a:t>
            </a:r>
          </a:p>
        </c:rich>
      </c:tx>
      <c:layout>
        <c:manualLayout>
          <c:xMode val="edge"/>
          <c:yMode val="edge"/>
          <c:x val="0.29677077865266843"/>
          <c:y val="8.333333333333332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8!$F$1</c:f>
              <c:strCache>
                <c:ptCount val="1"/>
                <c:pt idx="0">
                  <c:v>MNa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Sheet8!$E$2:$E$65</c:f>
              <c:numCache>
                <c:formatCode>General</c:formatCode>
                <c:ptCount val="64"/>
                <c:pt idx="0">
                  <c:v>-94763</c:v>
                </c:pt>
                <c:pt idx="1">
                  <c:v>-94740</c:v>
                </c:pt>
                <c:pt idx="2">
                  <c:v>-91317</c:v>
                </c:pt>
                <c:pt idx="3">
                  <c:v>-48170</c:v>
                </c:pt>
                <c:pt idx="4">
                  <c:v>-42157</c:v>
                </c:pt>
                <c:pt idx="5">
                  <c:v>-31953</c:v>
                </c:pt>
                <c:pt idx="6">
                  <c:v>-31044</c:v>
                </c:pt>
                <c:pt idx="7">
                  <c:v>-30884</c:v>
                </c:pt>
                <c:pt idx="8">
                  <c:v>-30880</c:v>
                </c:pt>
                <c:pt idx="9">
                  <c:v>-30738</c:v>
                </c:pt>
                <c:pt idx="10">
                  <c:v>-28944</c:v>
                </c:pt>
                <c:pt idx="11">
                  <c:v>-26298</c:v>
                </c:pt>
                <c:pt idx="12">
                  <c:v>-24847</c:v>
                </c:pt>
                <c:pt idx="13">
                  <c:v>-21571</c:v>
                </c:pt>
                <c:pt idx="14">
                  <c:v>-15284</c:v>
                </c:pt>
                <c:pt idx="15">
                  <c:v>-11394</c:v>
                </c:pt>
                <c:pt idx="16">
                  <c:v>-10474</c:v>
                </c:pt>
                <c:pt idx="17">
                  <c:v>-9086</c:v>
                </c:pt>
                <c:pt idx="18">
                  <c:v>-8990</c:v>
                </c:pt>
                <c:pt idx="19">
                  <c:v>-2460</c:v>
                </c:pt>
                <c:pt idx="20">
                  <c:v>-1706</c:v>
                </c:pt>
                <c:pt idx="21">
                  <c:v>-990</c:v>
                </c:pt>
                <c:pt idx="22">
                  <c:v>-473</c:v>
                </c:pt>
                <c:pt idx="23">
                  <c:v>-11</c:v>
                </c:pt>
                <c:pt idx="24">
                  <c:v>36</c:v>
                </c:pt>
                <c:pt idx="25">
                  <c:v>94</c:v>
                </c:pt>
                <c:pt idx="26">
                  <c:v>540</c:v>
                </c:pt>
                <c:pt idx="27">
                  <c:v>1854</c:v>
                </c:pt>
                <c:pt idx="28">
                  <c:v>1911</c:v>
                </c:pt>
                <c:pt idx="29">
                  <c:v>2041</c:v>
                </c:pt>
                <c:pt idx="30">
                  <c:v>2673</c:v>
                </c:pt>
                <c:pt idx="31">
                  <c:v>3032</c:v>
                </c:pt>
                <c:pt idx="32">
                  <c:v>3044</c:v>
                </c:pt>
                <c:pt idx="33">
                  <c:v>3085</c:v>
                </c:pt>
                <c:pt idx="34">
                  <c:v>3905</c:v>
                </c:pt>
                <c:pt idx="35">
                  <c:v>3955</c:v>
                </c:pt>
                <c:pt idx="36">
                  <c:v>4712</c:v>
                </c:pt>
                <c:pt idx="37">
                  <c:v>4740</c:v>
                </c:pt>
                <c:pt idx="38">
                  <c:v>6247</c:v>
                </c:pt>
                <c:pt idx="39">
                  <c:v>6289</c:v>
                </c:pt>
                <c:pt idx="40">
                  <c:v>6680</c:v>
                </c:pt>
                <c:pt idx="41">
                  <c:v>9202</c:v>
                </c:pt>
                <c:pt idx="42">
                  <c:v>9477</c:v>
                </c:pt>
                <c:pt idx="43">
                  <c:v>11323</c:v>
                </c:pt>
                <c:pt idx="44">
                  <c:v>11741</c:v>
                </c:pt>
                <c:pt idx="45">
                  <c:v>14998</c:v>
                </c:pt>
                <c:pt idx="46">
                  <c:v>16105</c:v>
                </c:pt>
                <c:pt idx="47">
                  <c:v>16454</c:v>
                </c:pt>
                <c:pt idx="48">
                  <c:v>16717</c:v>
                </c:pt>
                <c:pt idx="49">
                  <c:v>17758</c:v>
                </c:pt>
                <c:pt idx="50">
                  <c:v>18207</c:v>
                </c:pt>
                <c:pt idx="51">
                  <c:v>20423</c:v>
                </c:pt>
                <c:pt idx="52">
                  <c:v>23831</c:v>
                </c:pt>
                <c:pt idx="53">
                  <c:v>27787</c:v>
                </c:pt>
                <c:pt idx="54">
                  <c:v>33548</c:v>
                </c:pt>
                <c:pt idx="55">
                  <c:v>36720</c:v>
                </c:pt>
                <c:pt idx="56">
                  <c:v>38762</c:v>
                </c:pt>
                <c:pt idx="57">
                  <c:v>40280</c:v>
                </c:pt>
                <c:pt idx="58">
                  <c:v>40869</c:v>
                </c:pt>
                <c:pt idx="59">
                  <c:v>41894</c:v>
                </c:pt>
                <c:pt idx="60">
                  <c:v>43156</c:v>
                </c:pt>
                <c:pt idx="61">
                  <c:v>45380</c:v>
                </c:pt>
                <c:pt idx="62">
                  <c:v>52535</c:v>
                </c:pt>
                <c:pt idx="63">
                  <c:v>72936</c:v>
                </c:pt>
              </c:numCache>
            </c:numRef>
          </c:cat>
          <c:val>
            <c:numRef>
              <c:f>Sheet8!$F$2:$F$65</c:f>
              <c:numCache>
                <c:formatCode>General</c:formatCode>
                <c:ptCount val="64"/>
                <c:pt idx="0">
                  <c:v>24</c:v>
                </c:pt>
                <c:pt idx="1">
                  <c:v>28</c:v>
                </c:pt>
                <c:pt idx="2">
                  <c:v>22</c:v>
                </c:pt>
                <c:pt idx="3">
                  <c:v>28</c:v>
                </c:pt>
                <c:pt idx="4">
                  <c:v>2</c:v>
                </c:pt>
                <c:pt idx="5">
                  <c:v>10</c:v>
                </c:pt>
                <c:pt idx="6">
                  <c:v>20</c:v>
                </c:pt>
                <c:pt idx="7">
                  <c:v>16</c:v>
                </c:pt>
                <c:pt idx="8">
                  <c:v>4</c:v>
                </c:pt>
                <c:pt idx="9">
                  <c:v>3</c:v>
                </c:pt>
                <c:pt idx="10">
                  <c:v>18</c:v>
                </c:pt>
                <c:pt idx="11">
                  <c:v>5</c:v>
                </c:pt>
                <c:pt idx="12">
                  <c:v>8</c:v>
                </c:pt>
                <c:pt idx="13">
                  <c:v>17</c:v>
                </c:pt>
                <c:pt idx="14">
                  <c:v>31</c:v>
                </c:pt>
                <c:pt idx="15">
                  <c:v>3</c:v>
                </c:pt>
                <c:pt idx="16">
                  <c:v>56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  <c:pt idx="20">
                  <c:v>5</c:v>
                </c:pt>
                <c:pt idx="21">
                  <c:v>18</c:v>
                </c:pt>
                <c:pt idx="22">
                  <c:v>13</c:v>
                </c:pt>
                <c:pt idx="23">
                  <c:v>31</c:v>
                </c:pt>
                <c:pt idx="24">
                  <c:v>573</c:v>
                </c:pt>
                <c:pt idx="25">
                  <c:v>2</c:v>
                </c:pt>
                <c:pt idx="26">
                  <c:v>16</c:v>
                </c:pt>
                <c:pt idx="27">
                  <c:v>175</c:v>
                </c:pt>
                <c:pt idx="28">
                  <c:v>71</c:v>
                </c:pt>
                <c:pt idx="29">
                  <c:v>18</c:v>
                </c:pt>
                <c:pt idx="30">
                  <c:v>31</c:v>
                </c:pt>
                <c:pt idx="31">
                  <c:v>143</c:v>
                </c:pt>
                <c:pt idx="32">
                  <c:v>261</c:v>
                </c:pt>
                <c:pt idx="33">
                  <c:v>23</c:v>
                </c:pt>
                <c:pt idx="34">
                  <c:v>11</c:v>
                </c:pt>
                <c:pt idx="35">
                  <c:v>60</c:v>
                </c:pt>
                <c:pt idx="36">
                  <c:v>55</c:v>
                </c:pt>
                <c:pt idx="37">
                  <c:v>78</c:v>
                </c:pt>
                <c:pt idx="38">
                  <c:v>50</c:v>
                </c:pt>
                <c:pt idx="39">
                  <c:v>29</c:v>
                </c:pt>
                <c:pt idx="40">
                  <c:v>24</c:v>
                </c:pt>
                <c:pt idx="41">
                  <c:v>9</c:v>
                </c:pt>
                <c:pt idx="42">
                  <c:v>6</c:v>
                </c:pt>
                <c:pt idx="43">
                  <c:v>14</c:v>
                </c:pt>
                <c:pt idx="44">
                  <c:v>8</c:v>
                </c:pt>
                <c:pt idx="45">
                  <c:v>13</c:v>
                </c:pt>
                <c:pt idx="46">
                  <c:v>30</c:v>
                </c:pt>
                <c:pt idx="47">
                  <c:v>1</c:v>
                </c:pt>
                <c:pt idx="48">
                  <c:v>13</c:v>
                </c:pt>
                <c:pt idx="49">
                  <c:v>50</c:v>
                </c:pt>
                <c:pt idx="50">
                  <c:v>18</c:v>
                </c:pt>
                <c:pt idx="51">
                  <c:v>12</c:v>
                </c:pt>
                <c:pt idx="52">
                  <c:v>28</c:v>
                </c:pt>
                <c:pt idx="53">
                  <c:v>1</c:v>
                </c:pt>
                <c:pt idx="54">
                  <c:v>3</c:v>
                </c:pt>
                <c:pt idx="55">
                  <c:v>13</c:v>
                </c:pt>
                <c:pt idx="56">
                  <c:v>2</c:v>
                </c:pt>
                <c:pt idx="57">
                  <c:v>13</c:v>
                </c:pt>
                <c:pt idx="58">
                  <c:v>10</c:v>
                </c:pt>
                <c:pt idx="59">
                  <c:v>6</c:v>
                </c:pt>
                <c:pt idx="60">
                  <c:v>1</c:v>
                </c:pt>
                <c:pt idx="61">
                  <c:v>6</c:v>
                </c:pt>
                <c:pt idx="62">
                  <c:v>8</c:v>
                </c:pt>
                <c:pt idx="63">
                  <c:v>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ADA-4C5C-8B08-B4CD039243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1729584"/>
        <c:axId val="7453440"/>
      </c:lineChart>
      <c:catAx>
        <c:axId val="91729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53440"/>
        <c:crosses val="autoZero"/>
        <c:auto val="1"/>
        <c:lblAlgn val="ctr"/>
        <c:lblOffset val="100"/>
        <c:noMultiLvlLbl val="0"/>
      </c:catAx>
      <c:valAx>
        <c:axId val="7453440"/>
        <c:scaling>
          <c:orientation val="minMax"/>
          <c:max val="6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7295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/>
              <a:t>MECP2 </a:t>
            </a:r>
            <a:r>
              <a:rPr lang="en-US" b="1" dirty="0" err="1"/>
              <a:t>ChIP</a:t>
            </a:r>
            <a:r>
              <a:rPr lang="en-US" b="1" dirty="0"/>
              <a:t> -</a:t>
            </a:r>
            <a:r>
              <a:rPr lang="en-US" b="1" baseline="0" dirty="0"/>
              <a:t> 64 </a:t>
            </a:r>
            <a:r>
              <a:rPr lang="en-US" b="1" baseline="0" dirty="0" err="1"/>
              <a:t>CpG</a:t>
            </a:r>
            <a:r>
              <a:rPr lang="en-US" b="1" baseline="0" dirty="0"/>
              <a:t> sites</a:t>
            </a:r>
            <a:endParaRPr lang="en-US" b="1" dirty="0"/>
          </a:p>
        </c:rich>
      </c:tx>
      <c:layout>
        <c:manualLayout>
          <c:xMode val="edge"/>
          <c:yMode val="edge"/>
          <c:x val="0.28284711286089237"/>
          <c:y val="7.4074074074074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8!$G$1</c:f>
              <c:strCache>
                <c:ptCount val="1"/>
                <c:pt idx="0">
                  <c:v>ChIP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Sheet8!$E$2:$E$65</c:f>
              <c:numCache>
                <c:formatCode>General</c:formatCode>
                <c:ptCount val="64"/>
                <c:pt idx="0">
                  <c:v>-94763</c:v>
                </c:pt>
                <c:pt idx="1">
                  <c:v>-94740</c:v>
                </c:pt>
                <c:pt idx="2">
                  <c:v>-91317</c:v>
                </c:pt>
                <c:pt idx="3">
                  <c:v>-48170</c:v>
                </c:pt>
                <c:pt idx="4">
                  <c:v>-42157</c:v>
                </c:pt>
                <c:pt idx="5">
                  <c:v>-31953</c:v>
                </c:pt>
                <c:pt idx="6">
                  <c:v>-31044</c:v>
                </c:pt>
                <c:pt idx="7">
                  <c:v>-30884</c:v>
                </c:pt>
                <c:pt idx="8">
                  <c:v>-30880</c:v>
                </c:pt>
                <c:pt idx="9">
                  <c:v>-30738</c:v>
                </c:pt>
                <c:pt idx="10">
                  <c:v>-28944</c:v>
                </c:pt>
                <c:pt idx="11">
                  <c:v>-26298</c:v>
                </c:pt>
                <c:pt idx="12">
                  <c:v>-24847</c:v>
                </c:pt>
                <c:pt idx="13">
                  <c:v>-21571</c:v>
                </c:pt>
                <c:pt idx="14">
                  <c:v>-15284</c:v>
                </c:pt>
                <c:pt idx="15">
                  <c:v>-11394</c:v>
                </c:pt>
                <c:pt idx="16">
                  <c:v>-10474</c:v>
                </c:pt>
                <c:pt idx="17">
                  <c:v>-9086</c:v>
                </c:pt>
                <c:pt idx="18">
                  <c:v>-8990</c:v>
                </c:pt>
                <c:pt idx="19">
                  <c:v>-2460</c:v>
                </c:pt>
                <c:pt idx="20">
                  <c:v>-1706</c:v>
                </c:pt>
                <c:pt idx="21">
                  <c:v>-990</c:v>
                </c:pt>
                <c:pt idx="22">
                  <c:v>-473</c:v>
                </c:pt>
                <c:pt idx="23">
                  <c:v>-11</c:v>
                </c:pt>
                <c:pt idx="24">
                  <c:v>36</c:v>
                </c:pt>
                <c:pt idx="25">
                  <c:v>94</c:v>
                </c:pt>
                <c:pt idx="26">
                  <c:v>540</c:v>
                </c:pt>
                <c:pt idx="27">
                  <c:v>1854</c:v>
                </c:pt>
                <c:pt idx="28">
                  <c:v>1911</c:v>
                </c:pt>
                <c:pt idx="29">
                  <c:v>2041</c:v>
                </c:pt>
                <c:pt idx="30">
                  <c:v>2673</c:v>
                </c:pt>
                <c:pt idx="31">
                  <c:v>3032</c:v>
                </c:pt>
                <c:pt idx="32">
                  <c:v>3044</c:v>
                </c:pt>
                <c:pt idx="33">
                  <c:v>3085</c:v>
                </c:pt>
                <c:pt idx="34">
                  <c:v>3905</c:v>
                </c:pt>
                <c:pt idx="35">
                  <c:v>3955</c:v>
                </c:pt>
                <c:pt idx="36">
                  <c:v>4712</c:v>
                </c:pt>
                <c:pt idx="37">
                  <c:v>4740</c:v>
                </c:pt>
                <c:pt idx="38">
                  <c:v>6247</c:v>
                </c:pt>
                <c:pt idx="39">
                  <c:v>6289</c:v>
                </c:pt>
                <c:pt idx="40">
                  <c:v>6680</c:v>
                </c:pt>
                <c:pt idx="41">
                  <c:v>9202</c:v>
                </c:pt>
                <c:pt idx="42">
                  <c:v>9477</c:v>
                </c:pt>
                <c:pt idx="43">
                  <c:v>11323</c:v>
                </c:pt>
                <c:pt idx="44">
                  <c:v>11741</c:v>
                </c:pt>
                <c:pt idx="45">
                  <c:v>14998</c:v>
                </c:pt>
                <c:pt idx="46">
                  <c:v>16105</c:v>
                </c:pt>
                <c:pt idx="47">
                  <c:v>16454</c:v>
                </c:pt>
                <c:pt idx="48">
                  <c:v>16717</c:v>
                </c:pt>
                <c:pt idx="49">
                  <c:v>17758</c:v>
                </c:pt>
                <c:pt idx="50">
                  <c:v>18207</c:v>
                </c:pt>
                <c:pt idx="51">
                  <c:v>20423</c:v>
                </c:pt>
                <c:pt idx="52">
                  <c:v>23831</c:v>
                </c:pt>
                <c:pt idx="53">
                  <c:v>27787</c:v>
                </c:pt>
                <c:pt idx="54">
                  <c:v>33548</c:v>
                </c:pt>
                <c:pt idx="55">
                  <c:v>36720</c:v>
                </c:pt>
                <c:pt idx="56">
                  <c:v>38762</c:v>
                </c:pt>
                <c:pt idx="57">
                  <c:v>40280</c:v>
                </c:pt>
                <c:pt idx="58">
                  <c:v>40869</c:v>
                </c:pt>
                <c:pt idx="59">
                  <c:v>41894</c:v>
                </c:pt>
                <c:pt idx="60">
                  <c:v>43156</c:v>
                </c:pt>
                <c:pt idx="61">
                  <c:v>45380</c:v>
                </c:pt>
                <c:pt idx="62">
                  <c:v>52535</c:v>
                </c:pt>
                <c:pt idx="63">
                  <c:v>72936</c:v>
                </c:pt>
              </c:numCache>
            </c:numRef>
          </c:cat>
          <c:val>
            <c:numRef>
              <c:f>Sheet8!$G$2:$G$65</c:f>
              <c:numCache>
                <c:formatCode>General</c:formatCode>
                <c:ptCount val="64"/>
                <c:pt idx="0">
                  <c:v>1</c:v>
                </c:pt>
                <c:pt idx="1">
                  <c:v>2</c:v>
                </c:pt>
                <c:pt idx="2">
                  <c:v>2</c:v>
                </c:pt>
                <c:pt idx="3">
                  <c:v>3</c:v>
                </c:pt>
                <c:pt idx="4">
                  <c:v>5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1</c:v>
                </c:pt>
                <c:pt idx="10">
                  <c:v>2</c:v>
                </c:pt>
                <c:pt idx="11">
                  <c:v>3</c:v>
                </c:pt>
                <c:pt idx="12">
                  <c:v>3</c:v>
                </c:pt>
                <c:pt idx="13">
                  <c:v>3</c:v>
                </c:pt>
                <c:pt idx="14">
                  <c:v>3</c:v>
                </c:pt>
                <c:pt idx="15">
                  <c:v>2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2</c:v>
                </c:pt>
                <c:pt idx="20">
                  <c:v>2</c:v>
                </c:pt>
                <c:pt idx="21">
                  <c:v>2</c:v>
                </c:pt>
                <c:pt idx="22">
                  <c:v>2</c:v>
                </c:pt>
                <c:pt idx="23">
                  <c:v>2</c:v>
                </c:pt>
                <c:pt idx="24">
                  <c:v>10</c:v>
                </c:pt>
                <c:pt idx="25">
                  <c:v>1</c:v>
                </c:pt>
                <c:pt idx="26">
                  <c:v>2</c:v>
                </c:pt>
                <c:pt idx="27">
                  <c:v>1</c:v>
                </c:pt>
                <c:pt idx="28">
                  <c:v>3</c:v>
                </c:pt>
                <c:pt idx="29">
                  <c:v>2</c:v>
                </c:pt>
                <c:pt idx="30">
                  <c:v>1</c:v>
                </c:pt>
                <c:pt idx="31">
                  <c:v>4</c:v>
                </c:pt>
                <c:pt idx="32">
                  <c:v>6</c:v>
                </c:pt>
                <c:pt idx="33">
                  <c:v>5</c:v>
                </c:pt>
                <c:pt idx="34">
                  <c:v>1</c:v>
                </c:pt>
                <c:pt idx="35">
                  <c:v>5</c:v>
                </c:pt>
                <c:pt idx="36">
                  <c:v>3</c:v>
                </c:pt>
                <c:pt idx="37">
                  <c:v>3</c:v>
                </c:pt>
                <c:pt idx="38">
                  <c:v>2</c:v>
                </c:pt>
                <c:pt idx="39">
                  <c:v>5</c:v>
                </c:pt>
                <c:pt idx="40">
                  <c:v>2</c:v>
                </c:pt>
                <c:pt idx="41">
                  <c:v>1</c:v>
                </c:pt>
                <c:pt idx="42">
                  <c:v>3</c:v>
                </c:pt>
                <c:pt idx="43">
                  <c:v>1</c:v>
                </c:pt>
                <c:pt idx="44">
                  <c:v>3</c:v>
                </c:pt>
                <c:pt idx="45">
                  <c:v>2</c:v>
                </c:pt>
                <c:pt idx="46">
                  <c:v>5</c:v>
                </c:pt>
                <c:pt idx="47">
                  <c:v>2</c:v>
                </c:pt>
                <c:pt idx="48">
                  <c:v>1</c:v>
                </c:pt>
                <c:pt idx="49">
                  <c:v>1</c:v>
                </c:pt>
                <c:pt idx="50">
                  <c:v>1</c:v>
                </c:pt>
                <c:pt idx="51">
                  <c:v>3</c:v>
                </c:pt>
                <c:pt idx="52">
                  <c:v>4</c:v>
                </c:pt>
                <c:pt idx="53">
                  <c:v>4</c:v>
                </c:pt>
                <c:pt idx="54">
                  <c:v>1</c:v>
                </c:pt>
                <c:pt idx="55">
                  <c:v>1</c:v>
                </c:pt>
                <c:pt idx="56">
                  <c:v>3</c:v>
                </c:pt>
                <c:pt idx="57">
                  <c:v>3</c:v>
                </c:pt>
                <c:pt idx="58">
                  <c:v>1</c:v>
                </c:pt>
                <c:pt idx="59">
                  <c:v>1</c:v>
                </c:pt>
                <c:pt idx="60">
                  <c:v>2</c:v>
                </c:pt>
                <c:pt idx="61">
                  <c:v>3</c:v>
                </c:pt>
                <c:pt idx="62">
                  <c:v>1</c:v>
                </c:pt>
                <c:pt idx="63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4FE-499E-8CCF-211CF498E0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7312296"/>
        <c:axId val="187359840"/>
      </c:lineChart>
      <c:catAx>
        <c:axId val="187312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359840"/>
        <c:crosses val="autoZero"/>
        <c:auto val="1"/>
        <c:lblAlgn val="ctr"/>
        <c:lblOffset val="100"/>
        <c:noMultiLvlLbl val="0"/>
      </c:catAx>
      <c:valAx>
        <c:axId val="187359840"/>
        <c:scaling>
          <c:orientation val="minMax"/>
          <c:max val="10.199999999999999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3122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5892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9509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6471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8530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8312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9860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8119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768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6474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629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1797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38BC6A-8F32-4F9B-B43E-EC6ABC3DAAED}" type="datetimeFigureOut">
              <a:rPr lang="en-GB" smtClean="0"/>
              <a:t>09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F07BFB-8578-4D8F-A9C3-6FAA2190B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395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/>
          <p:cNvGrpSpPr/>
          <p:nvPr/>
        </p:nvGrpSpPr>
        <p:grpSpPr>
          <a:xfrm>
            <a:off x="620202" y="868286"/>
            <a:ext cx="3039387" cy="5825645"/>
            <a:chOff x="609600" y="151230"/>
            <a:chExt cx="3124200" cy="6542702"/>
          </a:xfrm>
        </p:grpSpPr>
        <p:grpSp>
          <p:nvGrpSpPr>
            <p:cNvPr id="38" name="Group 37"/>
            <p:cNvGrpSpPr/>
            <p:nvPr/>
          </p:nvGrpSpPr>
          <p:grpSpPr>
            <a:xfrm>
              <a:off x="762000" y="523875"/>
              <a:ext cx="2971800" cy="5810250"/>
              <a:chOff x="762000" y="523875"/>
              <a:chExt cx="2971800" cy="5810250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2000" y="523875"/>
                <a:ext cx="2828925" cy="5810250"/>
              </a:xfrm>
              <a:prstGeom prst="rect">
                <a:avLst/>
              </a:prstGeom>
            </p:spPr>
          </p:pic>
          <p:cxnSp>
            <p:nvCxnSpPr>
              <p:cNvPr id="7" name="Straight Connector 6"/>
              <p:cNvCxnSpPr/>
              <p:nvPr/>
            </p:nvCxnSpPr>
            <p:spPr>
              <a:xfrm>
                <a:off x="3733800" y="533400"/>
                <a:ext cx="0" cy="685800"/>
              </a:xfrm>
              <a:prstGeom prst="line">
                <a:avLst/>
              </a:prstGeom>
              <a:ln w="57150">
                <a:solidFill>
                  <a:srgbClr val="2110FC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/>
              <p:cNvCxnSpPr/>
              <p:nvPr/>
            </p:nvCxnSpPr>
            <p:spPr>
              <a:xfrm>
                <a:off x="3733800" y="1219200"/>
                <a:ext cx="0" cy="609600"/>
              </a:xfrm>
              <a:prstGeom prst="line">
                <a:avLst/>
              </a:prstGeom>
              <a:ln w="57150">
                <a:solidFill>
                  <a:srgbClr val="C40CB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>
                <a:off x="3733800" y="1828800"/>
                <a:ext cx="0" cy="685800"/>
              </a:xfrm>
              <a:prstGeom prst="line">
                <a:avLst/>
              </a:prstGeom>
              <a:ln w="571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>
                <a:off x="3733800" y="2514600"/>
                <a:ext cx="0" cy="914400"/>
              </a:xfrm>
              <a:prstGeom prst="line">
                <a:avLst/>
              </a:prstGeom>
              <a:ln w="5715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>
                <a:off x="3733800" y="3429000"/>
                <a:ext cx="0" cy="2905125"/>
              </a:xfrm>
              <a:prstGeom prst="line">
                <a:avLst/>
              </a:prstGeom>
              <a:ln w="57150">
                <a:solidFill>
                  <a:schemeClr val="accent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9" name="TextBox 38"/>
            <p:cNvSpPr txBox="1"/>
            <p:nvPr/>
          </p:nvSpPr>
          <p:spPr>
            <a:xfrm>
              <a:off x="762001" y="151230"/>
              <a:ext cx="2828925" cy="41479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MECP2 </a:t>
              </a:r>
              <a:r>
                <a:rPr lang="en-GB" b="1" dirty="0" err="1"/>
                <a:t>ChIP</a:t>
              </a:r>
              <a:r>
                <a:rPr lang="en-GB" b="1" dirty="0"/>
                <a:t>      </a:t>
              </a:r>
              <a:r>
                <a:rPr lang="en-GB" b="1" dirty="0" err="1"/>
                <a:t>MNase-seq</a:t>
              </a:r>
              <a:endParaRPr lang="en-GB" b="1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09600" y="6324600"/>
              <a:ext cx="18710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+5kb    </a:t>
              </a:r>
              <a:r>
                <a:rPr lang="en-GB" b="1" dirty="0" err="1"/>
                <a:t>CpG</a:t>
              </a:r>
              <a:r>
                <a:rPr lang="en-GB" b="1" dirty="0"/>
                <a:t>   -5kb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C62D44F-1F74-4859-B7AE-C5969C9CC73D}"/>
              </a:ext>
            </a:extLst>
          </p:cNvPr>
          <p:cNvGrpSpPr/>
          <p:nvPr/>
        </p:nvGrpSpPr>
        <p:grpSpPr>
          <a:xfrm>
            <a:off x="7913785" y="2276475"/>
            <a:ext cx="3952875" cy="2305050"/>
            <a:chOff x="2600325" y="2276475"/>
            <a:chExt cx="3952875" cy="2305050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70394777-6783-4BB4-B261-AF4A64F9187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00325" y="2276475"/>
              <a:ext cx="3943350" cy="2305050"/>
            </a:xfrm>
            <a:prstGeom prst="rect">
              <a:avLst/>
            </a:prstGeom>
          </p:spPr>
        </p:pic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E3F1A4C-BCA7-4E4F-B90A-10719470F862}"/>
                </a:ext>
              </a:extLst>
            </p:cNvPr>
            <p:cNvSpPr/>
            <p:nvPr/>
          </p:nvSpPr>
          <p:spPr>
            <a:xfrm>
              <a:off x="5181600" y="2286000"/>
              <a:ext cx="1371600" cy="53340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b="1" dirty="0" err="1">
                  <a:solidFill>
                    <a:srgbClr val="C40CB7"/>
                  </a:solidFill>
                </a:rPr>
                <a:t>Mnase-seq</a:t>
              </a:r>
              <a:endParaRPr lang="en-GB" b="1" dirty="0">
                <a:solidFill>
                  <a:srgbClr val="C40CB7"/>
                </a:solidFill>
              </a:endParaRPr>
            </a:p>
            <a:p>
              <a:pPr algn="ctr"/>
              <a:r>
                <a:rPr lang="en-GB" b="1" dirty="0">
                  <a:solidFill>
                    <a:srgbClr val="2110FC"/>
                  </a:solidFill>
                </a:rPr>
                <a:t>Mecp2 </a:t>
              </a:r>
              <a:r>
                <a:rPr lang="en-GB" b="1" dirty="0" err="1">
                  <a:solidFill>
                    <a:srgbClr val="2110FC"/>
                  </a:solidFill>
                </a:rPr>
                <a:t>ChIP</a:t>
              </a:r>
              <a:endParaRPr lang="en-GB" b="1" dirty="0">
                <a:solidFill>
                  <a:srgbClr val="2110FC"/>
                </a:solidFill>
              </a:endParaRP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5CC895ED-BE54-49E5-B003-19799BC01AAC}"/>
              </a:ext>
            </a:extLst>
          </p:cNvPr>
          <p:cNvSpPr txBox="1"/>
          <p:nvPr/>
        </p:nvSpPr>
        <p:spPr>
          <a:xfrm>
            <a:off x="7913785" y="197437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5ACE1C84-358A-4A74-925E-44077FA6CB2F}"/>
              </a:ext>
            </a:extLst>
          </p:cNvPr>
          <p:cNvGrpSpPr/>
          <p:nvPr/>
        </p:nvGrpSpPr>
        <p:grpSpPr>
          <a:xfrm>
            <a:off x="3874269" y="3495683"/>
            <a:ext cx="3934371" cy="2942431"/>
            <a:chOff x="1905000" y="4038600"/>
            <a:chExt cx="4953000" cy="3015734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05F827A-543B-4F43-AB44-1059430BB2D8}"/>
                </a:ext>
              </a:extLst>
            </p:cNvPr>
            <p:cNvSpPr txBox="1"/>
            <p:nvPr/>
          </p:nvSpPr>
          <p:spPr>
            <a:xfrm>
              <a:off x="1905000" y="4801350"/>
              <a:ext cx="461665" cy="129465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GB" b="1" dirty="0"/>
                <a:t>Tag intensity</a:t>
              </a:r>
            </a:p>
          </p:txBody>
        </p: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9FA43D58-30D9-491A-A859-BA494CEBB92B}"/>
                </a:ext>
              </a:extLst>
            </p:cNvPr>
            <p:cNvGrpSpPr/>
            <p:nvPr/>
          </p:nvGrpSpPr>
          <p:grpSpPr>
            <a:xfrm>
              <a:off x="2286000" y="4038600"/>
              <a:ext cx="4572000" cy="3015734"/>
              <a:chOff x="2286000" y="4038600"/>
              <a:chExt cx="4572000" cy="3015734"/>
            </a:xfrm>
          </p:grpSpPr>
          <p:graphicFrame>
            <p:nvGraphicFramePr>
              <p:cNvPr id="21" name="Chart 20">
                <a:extLst>
                  <a:ext uri="{FF2B5EF4-FFF2-40B4-BE49-F238E27FC236}">
                    <a16:creationId xmlns:a16="http://schemas.microsoft.com/office/drawing/2014/main" id="{98F25AF2-3233-4C7F-B60B-437BFDBBEAE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6274503"/>
                  </p:ext>
                </p:extLst>
              </p:nvPr>
            </p:nvGraphicFramePr>
            <p:xfrm>
              <a:off x="2286000" y="4038600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502E599-D44D-43A1-AB5D-194673E9826F}"/>
                  </a:ext>
                </a:extLst>
              </p:cNvPr>
              <p:cNvSpPr txBox="1"/>
              <p:nvPr/>
            </p:nvSpPr>
            <p:spPr>
              <a:xfrm>
                <a:off x="3466421" y="6685002"/>
                <a:ext cx="1902316" cy="369332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GB" b="1" dirty="0"/>
                  <a:t>Distance from TSS</a:t>
                </a:r>
              </a:p>
            </p:txBody>
          </p:sp>
        </p:grp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7CC77C8F-C835-48C6-B95A-42C0BBDAB59D}"/>
              </a:ext>
            </a:extLst>
          </p:cNvPr>
          <p:cNvGrpSpPr/>
          <p:nvPr/>
        </p:nvGrpSpPr>
        <p:grpSpPr>
          <a:xfrm>
            <a:off x="3875600" y="636111"/>
            <a:ext cx="3813313" cy="2899564"/>
            <a:chOff x="2057400" y="1295400"/>
            <a:chExt cx="4800600" cy="2971800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47AAC06-F4AF-4854-A0B0-81426354C856}"/>
                </a:ext>
              </a:extLst>
            </p:cNvPr>
            <p:cNvSpPr txBox="1"/>
            <p:nvPr/>
          </p:nvSpPr>
          <p:spPr>
            <a:xfrm>
              <a:off x="2057400" y="2029892"/>
              <a:ext cx="461665" cy="129465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GB" b="1" dirty="0"/>
                <a:t>Tag intensity</a:t>
              </a: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E138D586-3228-49EB-854B-C0EFBC161F5D}"/>
                </a:ext>
              </a:extLst>
            </p:cNvPr>
            <p:cNvGrpSpPr/>
            <p:nvPr/>
          </p:nvGrpSpPr>
          <p:grpSpPr>
            <a:xfrm>
              <a:off x="2286000" y="1295400"/>
              <a:ext cx="4572000" cy="2971800"/>
              <a:chOff x="2286000" y="1295400"/>
              <a:chExt cx="4572000" cy="2971800"/>
            </a:xfrm>
          </p:grpSpPr>
          <p:graphicFrame>
            <p:nvGraphicFramePr>
              <p:cNvPr id="26" name="Chart 25">
                <a:extLst>
                  <a:ext uri="{FF2B5EF4-FFF2-40B4-BE49-F238E27FC236}">
                    <a16:creationId xmlns:a16="http://schemas.microsoft.com/office/drawing/2014/main" id="{C7F264E4-BCEC-4834-93FB-C296708FDA3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30026125"/>
                  </p:ext>
                </p:extLst>
              </p:nvPr>
            </p:nvGraphicFramePr>
            <p:xfrm>
              <a:off x="2286000" y="1295400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F6F930F1-E849-48A7-B506-59A7EAB8E9AF}"/>
                  </a:ext>
                </a:extLst>
              </p:cNvPr>
              <p:cNvSpPr txBox="1"/>
              <p:nvPr/>
            </p:nvSpPr>
            <p:spPr>
              <a:xfrm>
                <a:off x="3466421" y="3897868"/>
                <a:ext cx="1902316" cy="369332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GB" b="1" dirty="0"/>
                  <a:t>Distance from TSS</a:t>
                </a:r>
              </a:p>
            </p:txBody>
          </p:sp>
        </p:grp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ED2A50E1-1F8C-4A6B-A10D-0E6076470C10}"/>
              </a:ext>
            </a:extLst>
          </p:cNvPr>
          <p:cNvSpPr txBox="1"/>
          <p:nvPr/>
        </p:nvSpPr>
        <p:spPr>
          <a:xfrm>
            <a:off x="4057186" y="49895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7FC3C4F-C676-468E-881A-4464B37AC0D5}"/>
              </a:ext>
            </a:extLst>
          </p:cNvPr>
          <p:cNvSpPr txBox="1"/>
          <p:nvPr/>
        </p:nvSpPr>
        <p:spPr>
          <a:xfrm>
            <a:off x="768465" y="49600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306233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35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zil</dc:creator>
  <cp:lastModifiedBy>bazil</cp:lastModifiedBy>
  <cp:revision>8</cp:revision>
  <dcterms:created xsi:type="dcterms:W3CDTF">2017-06-24T23:15:39Z</dcterms:created>
  <dcterms:modified xsi:type="dcterms:W3CDTF">2017-09-10T04:54:54Z</dcterms:modified>
</cp:coreProperties>
</file>